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9EED1A-69C0-4AEF-A605-A2C9D44A28A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B97F49-415B-49A0-80BC-4DB12E4CFE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22BB6A-BBA2-41EE-9D73-55FA86F01DB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F6C38A-03B1-4E78-AB61-B3DF2B2D764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423128-B910-4735-A42B-B92BD9BE5B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CDEAF3-46D8-48F0-86FE-7B3CBA8F3E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6910E8-01AA-4166-8963-30A32AA421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54CA6A-41AF-4FD0-B882-B8F87257EF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398853-8036-4F4E-8BEF-3F3BC1D6A3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D2F419-2600-4EF2-91F4-E9F6CD14DF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A9DACA-ADA8-45D5-9E3C-9A4766356C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0C75CE-A2DD-46AF-95FE-40A72DF9A2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E30B60-A942-4B92-9B5E-95FF14FFF7C2}" type="slidenum"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09480" y="6094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609480" y="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609480" y="10666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609480" y="14479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609480" y="1905120"/>
            <a:ext cx="1524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304920" y="3049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304920" y="4572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.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228600" y="9144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2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228600" y="16002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8.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228600" y="17524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3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228600" y="28195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75.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4648320" y="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4648320" y="14479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4343400" y="3049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4267080" y="12193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0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4191120" y="281952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04.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838080" y="2819520"/>
            <a:ext cx="1905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AG03AG, ASAG01AG, ASAA07AC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838080" y="2286000"/>
            <a:ext cx="1828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AT01TA, AJCC03TT, ASAT03T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2133720" y="2438280"/>
            <a:ext cx="1981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AA06AA, AJAA07AA, AJTA03TA,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TC01CT, AJTT02AT, AJTC01T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838080" y="1981080"/>
            <a:ext cx="1447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TG02AA, MSP-1,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GT08AT, AJTT07A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838080" y="1295280"/>
            <a:ext cx="137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AC01TG, AJAC02A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838080" y="304920"/>
            <a:ext cx="1447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CA02AA, hsp8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4876920" y="334800"/>
            <a:ext cx="1218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an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4876920" y="1905120"/>
            <a:ext cx="129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AT04AA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4876920" y="2819520"/>
            <a:ext cx="1752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g3027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66" name=""/>
          <p:cNvGrpSpPr/>
          <p:nvPr/>
        </p:nvGrpSpPr>
        <p:grpSpPr>
          <a:xfrm>
            <a:off x="609480" y="3657600"/>
            <a:ext cx="228600" cy="2516040"/>
            <a:chOff x="609480" y="3657600"/>
            <a:chExt cx="228600" cy="2516040"/>
          </a:xfrm>
        </p:grpSpPr>
        <p:grpSp>
          <p:nvGrpSpPr>
            <p:cNvPr id="67" name=""/>
            <p:cNvGrpSpPr/>
            <p:nvPr/>
          </p:nvGrpSpPr>
          <p:grpSpPr>
            <a:xfrm>
              <a:off x="609480" y="3657600"/>
              <a:ext cx="228600" cy="2516040"/>
              <a:chOff x="609480" y="3657600"/>
              <a:chExt cx="228600" cy="2516040"/>
            </a:xfrm>
          </p:grpSpPr>
          <p:sp>
            <p:nvSpPr>
              <p:cNvPr id="68" name=""/>
              <p:cNvSpPr/>
              <p:nvPr/>
            </p:nvSpPr>
            <p:spPr>
              <a:xfrm>
                <a:off x="685800" y="3659040"/>
                <a:ext cx="76320" cy="25146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609480" y="365760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70" name=""/>
            <p:cNvSpPr/>
            <p:nvPr/>
          </p:nvSpPr>
          <p:spPr>
            <a:xfrm>
              <a:off x="609480" y="617364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71" name=""/>
          <p:cNvSpPr/>
          <p:nvPr/>
        </p:nvSpPr>
        <p:spPr>
          <a:xfrm>
            <a:off x="304920" y="35053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152280" y="6019920"/>
            <a:ext cx="68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60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609480" y="39625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609480" y="44197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609480" y="41148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609480" y="51055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228600" y="38098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7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228600" y="39909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0.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228600" y="42670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8.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228600" y="49528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89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609480" y="327672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838080" y="3505320"/>
            <a:ext cx="1676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APB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838080" y="3962520"/>
            <a:ext cx="2438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AC02AC, AJCG01CT, AJAG03AC, ASTT01TT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838080" y="4267080"/>
            <a:ext cx="2895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AT05AG, AJGA02CA, AJGA01CA, ASGA01CA, AJGA03AG, AJAC02AA, ASAT05AA, ASTA02AG, AJCC03CA, ASCC01GT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838080" y="4952880"/>
            <a:ext cx="1828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Courier New"/>
              </a:rPr>
              <a:t>cDNA121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838080" y="6019920"/>
            <a:ext cx="198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5SrRN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7" name=""/>
          <p:cNvGrpSpPr/>
          <p:nvPr/>
        </p:nvGrpSpPr>
        <p:grpSpPr>
          <a:xfrm>
            <a:off x="4648320" y="457200"/>
            <a:ext cx="228600" cy="2516040"/>
            <a:chOff x="4648320" y="457200"/>
            <a:chExt cx="228600" cy="2516040"/>
          </a:xfrm>
        </p:grpSpPr>
        <p:grpSp>
          <p:nvGrpSpPr>
            <p:cNvPr id="88" name=""/>
            <p:cNvGrpSpPr/>
            <p:nvPr/>
          </p:nvGrpSpPr>
          <p:grpSpPr>
            <a:xfrm>
              <a:off x="4648320" y="457200"/>
              <a:ext cx="228600" cy="2516040"/>
              <a:chOff x="4648320" y="457200"/>
              <a:chExt cx="228600" cy="2516040"/>
            </a:xfrm>
          </p:grpSpPr>
          <p:sp>
            <p:nvSpPr>
              <p:cNvPr id="89" name=""/>
              <p:cNvSpPr/>
              <p:nvPr/>
            </p:nvSpPr>
            <p:spPr>
              <a:xfrm>
                <a:off x="4724640" y="458640"/>
                <a:ext cx="76320" cy="25146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4648320" y="45720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91" name=""/>
            <p:cNvSpPr/>
            <p:nvPr/>
          </p:nvSpPr>
          <p:spPr>
            <a:xfrm>
              <a:off x="4648320" y="297324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92" name=""/>
          <p:cNvGrpSpPr/>
          <p:nvPr/>
        </p:nvGrpSpPr>
        <p:grpSpPr>
          <a:xfrm>
            <a:off x="609480" y="457200"/>
            <a:ext cx="228600" cy="2516040"/>
            <a:chOff x="609480" y="457200"/>
            <a:chExt cx="228600" cy="2516040"/>
          </a:xfrm>
        </p:grpSpPr>
        <p:grpSp>
          <p:nvGrpSpPr>
            <p:cNvPr id="93" name=""/>
            <p:cNvGrpSpPr/>
            <p:nvPr/>
          </p:nvGrpSpPr>
          <p:grpSpPr>
            <a:xfrm>
              <a:off x="609480" y="457200"/>
              <a:ext cx="228600" cy="2516040"/>
              <a:chOff x="609480" y="457200"/>
              <a:chExt cx="228600" cy="2516040"/>
            </a:xfrm>
          </p:grpSpPr>
          <p:sp>
            <p:nvSpPr>
              <p:cNvPr id="94" name=""/>
              <p:cNvSpPr/>
              <p:nvPr/>
            </p:nvSpPr>
            <p:spPr>
              <a:xfrm>
                <a:off x="685800" y="458640"/>
                <a:ext cx="76320" cy="25146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609480" y="45720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96" name=""/>
            <p:cNvSpPr/>
            <p:nvPr/>
          </p:nvSpPr>
          <p:spPr>
            <a:xfrm>
              <a:off x="609480" y="297324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7" name=""/>
          <p:cNvSpPr/>
          <p:nvPr/>
        </p:nvSpPr>
        <p:spPr>
          <a:xfrm>
            <a:off x="4324320" y="3467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4629240" y="3762360"/>
            <a:ext cx="1762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4638600" y="4191120"/>
            <a:ext cx="1228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4638600" y="40384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4629240" y="43434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4648320" y="4648320"/>
            <a:ext cx="1143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4619520" y="4857840"/>
            <a:ext cx="939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4629240" y="50292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4635360" y="586116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4635360" y="53341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4622760" y="55720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4629240" y="3886200"/>
            <a:ext cx="1390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4317840" y="360684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.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4317840" y="37591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9.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4267080" y="38862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3.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4267080" y="41911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1.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4267080" y="44956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1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4267080" y="47242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9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4267080" y="50292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8.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4267080" y="54100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64.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4267080" y="55627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70.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4267080" y="48769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4.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4267080" y="571500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75.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20" name=""/>
          <p:cNvGrpSpPr/>
          <p:nvPr/>
        </p:nvGrpSpPr>
        <p:grpSpPr>
          <a:xfrm>
            <a:off x="4629240" y="3619440"/>
            <a:ext cx="228600" cy="2516040"/>
            <a:chOff x="4629240" y="3619440"/>
            <a:chExt cx="228600" cy="2516040"/>
          </a:xfrm>
        </p:grpSpPr>
        <p:grpSp>
          <p:nvGrpSpPr>
            <p:cNvPr id="121" name=""/>
            <p:cNvGrpSpPr/>
            <p:nvPr/>
          </p:nvGrpSpPr>
          <p:grpSpPr>
            <a:xfrm>
              <a:off x="4629240" y="3619440"/>
              <a:ext cx="228600" cy="2516040"/>
              <a:chOff x="4629240" y="3619440"/>
              <a:chExt cx="228600" cy="2516040"/>
            </a:xfrm>
          </p:grpSpPr>
          <p:sp>
            <p:nvSpPr>
              <p:cNvPr id="122" name=""/>
              <p:cNvSpPr/>
              <p:nvPr/>
            </p:nvSpPr>
            <p:spPr>
              <a:xfrm>
                <a:off x="4705560" y="3620880"/>
                <a:ext cx="76320" cy="25146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4629240" y="361944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24" name=""/>
            <p:cNvSpPr/>
            <p:nvPr/>
          </p:nvSpPr>
          <p:spPr>
            <a:xfrm>
              <a:off x="4629240" y="613548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25" name=""/>
          <p:cNvSpPr/>
          <p:nvPr/>
        </p:nvSpPr>
        <p:spPr>
          <a:xfrm>
            <a:off x="4626000" y="56959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4635360" y="51814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>
            <a:off x="4876920" y="3505320"/>
            <a:ext cx="213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PL-04, CRK2, EF-1α, PCNA</a:t>
            </a: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>
            <a:off x="6324480" y="3581280"/>
            <a:ext cx="281952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AG02CA, ASAT01TA, AJAT03CT, ASCA01CT, ASCA01GA, ASCT03TG, ASCA03AT, ASTC02AC, ASAT03A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>
            <a:off x="6324480" y="4038480"/>
            <a:ext cx="2667240" cy="23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TT03AT, AJTT03CA, AJAC01CA, ASTT08AA, ASTT02AA, AJTA01TT, AJTT02GA, ASAC04TT</a:t>
            </a:r>
            <a:r>
              <a:rPr b="1" lang="en-GB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>
            <a:off x="4267080" y="40384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7.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>
            <a:off x="4876920" y="3886200"/>
            <a:ext cx="799920" cy="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TT03AA</a:t>
            </a:r>
            <a:r>
              <a:rPr b="1" lang="en-GB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6324480" y="4419720"/>
            <a:ext cx="2667240" cy="23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CG02AT, ASCG01TA, AJCC02AA, AJCT03TC, AJCC04TT, ASGT01AA, AJGT03AA, ASAA01TG, AJAT03AA</a:t>
            </a:r>
            <a:r>
              <a:rPr b="1" lang="en-GB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4876920" y="4191120"/>
            <a:ext cx="1076040" cy="239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AT03GA, ASTC01CA, AJAT01AA</a:t>
            </a:r>
            <a:r>
              <a:rPr b="1" lang="en-GB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>
            <a:off x="6324480" y="4876920"/>
            <a:ext cx="20671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CA03TT, AJTT04TA, AJCT01TC, AJGA02TT, AJCA02GT, AJGT01AC</a:t>
            </a:r>
            <a:r>
              <a:rPr b="1" lang="en-GB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>
            <a:off x="4876920" y="4876920"/>
            <a:ext cx="799920" cy="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AT06CT</a:t>
            </a:r>
            <a:r>
              <a:rPr b="1" lang="en-GB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>
            <a:off x="4267080" y="51814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2.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>
            <a:off x="6324480" y="5257800"/>
            <a:ext cx="24861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TG05AT, ASTG01TA, ASTC01AC, AJTA01TA, ASTA01TA, ASAT02TA, AJCA01CA</a:t>
            </a:r>
            <a:r>
              <a:rPr b="1" lang="en-GB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4876920" y="5410080"/>
            <a:ext cx="73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TopoI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>
            <a:off x="4876920" y="5181480"/>
            <a:ext cx="1295280" cy="23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AC02TA, AJAC01TA</a:t>
            </a:r>
            <a:r>
              <a:rPr b="1" lang="en-GB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>
            <a:off x="4876920" y="5029200"/>
            <a:ext cx="12952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AG01TA, AJAG01TA</a:t>
            </a:r>
            <a:r>
              <a:rPr b="1" lang="en-GB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>
            <a:off x="4876920" y="6019920"/>
            <a:ext cx="4572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H2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"/>
          <p:cNvSpPr/>
          <p:nvPr/>
        </p:nvSpPr>
        <p:spPr>
          <a:xfrm>
            <a:off x="4267080" y="6019920"/>
            <a:ext cx="48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87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>
            <a:off x="4572000" y="320040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>
            <a:off x="228600" y="12952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0.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"/>
          <p:cNvSpPr/>
          <p:nvPr/>
        </p:nvSpPr>
        <p:spPr>
          <a:xfrm>
            <a:off x="609480" y="17524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>
            <a:off x="2133720" y="1752480"/>
            <a:ext cx="19810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CA03AG, ASCA02AA, AJGT02TA, AJAC02AG, ASCT02TA, AJCT04TA, ASGA02AC, AJTA04AT, ASTA01A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"/>
          <p:cNvSpPr/>
          <p:nvPr/>
        </p:nvSpPr>
        <p:spPr>
          <a:xfrm>
            <a:off x="838080" y="1600200"/>
            <a:ext cx="838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AG01C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"/>
          <p:cNvSpPr/>
          <p:nvPr/>
        </p:nvSpPr>
        <p:spPr>
          <a:xfrm>
            <a:off x="609480" y="21337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"/>
          <p:cNvSpPr/>
          <p:nvPr/>
        </p:nvSpPr>
        <p:spPr>
          <a:xfrm>
            <a:off x="228600" y="19810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0.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"/>
          <p:cNvSpPr/>
          <p:nvPr/>
        </p:nvSpPr>
        <p:spPr>
          <a:xfrm>
            <a:off x="609480" y="24382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>
            <a:off x="838080" y="914400"/>
            <a:ext cx="762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TG03A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>
            <a:off x="228600" y="22860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5.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>
            <a:off x="609480" y="2590920"/>
            <a:ext cx="1524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>
            <a:off x="228600" y="24382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9.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>
            <a:off x="838080" y="457200"/>
            <a:ext cx="19051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AC01AT, AJAC03AT, ASAT03AC, ASCA02TG, AJCA02T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"/>
          <p:cNvSpPr/>
          <p:nvPr/>
        </p:nvSpPr>
        <p:spPr>
          <a:xfrm>
            <a:off x="4876920" y="2286000"/>
            <a:ext cx="426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AT04TA, AJAA04AA, AJCA01GT, AJCG01GT, ASCG01G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"/>
          <p:cNvSpPr/>
          <p:nvPr/>
        </p:nvSpPr>
        <p:spPr>
          <a:xfrm>
            <a:off x="4648320" y="16002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"/>
          <p:cNvSpPr/>
          <p:nvPr/>
        </p:nvSpPr>
        <p:spPr>
          <a:xfrm>
            <a:off x="4648320" y="18288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"/>
          <p:cNvSpPr/>
          <p:nvPr/>
        </p:nvSpPr>
        <p:spPr>
          <a:xfrm>
            <a:off x="4876920" y="1676520"/>
            <a:ext cx="4267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AC01AA, AJCC04CA, AJAC03AA, ASAC03CT, AJAC01CT, ASTT05CA, ASCC02AC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"/>
          <p:cNvSpPr/>
          <p:nvPr/>
        </p:nvSpPr>
        <p:spPr>
          <a:xfrm>
            <a:off x="4267080" y="14479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4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"/>
          <p:cNvSpPr/>
          <p:nvPr/>
        </p:nvSpPr>
        <p:spPr>
          <a:xfrm>
            <a:off x="4267080" y="16765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1.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"/>
          <p:cNvSpPr/>
          <p:nvPr/>
        </p:nvSpPr>
        <p:spPr>
          <a:xfrm>
            <a:off x="4876920" y="1447920"/>
            <a:ext cx="1752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GT05A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"/>
          <p:cNvSpPr/>
          <p:nvPr/>
        </p:nvSpPr>
        <p:spPr>
          <a:xfrm>
            <a:off x="4648320" y="20574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"/>
          <p:cNvSpPr/>
          <p:nvPr/>
        </p:nvSpPr>
        <p:spPr>
          <a:xfrm>
            <a:off x="4267080" y="19051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9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"/>
          <p:cNvSpPr/>
          <p:nvPr/>
        </p:nvSpPr>
        <p:spPr>
          <a:xfrm>
            <a:off x="4876920" y="1295280"/>
            <a:ext cx="3809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TA01GT, ASAA04CA, AJAT01TC, ASAT04TC, ASTA01GT, AJAT05T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"/>
          <p:cNvSpPr/>
          <p:nvPr/>
        </p:nvSpPr>
        <p:spPr>
          <a:xfrm>
            <a:off x="4648320" y="22096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"/>
          <p:cNvSpPr/>
          <p:nvPr/>
        </p:nvSpPr>
        <p:spPr>
          <a:xfrm>
            <a:off x="4267080" y="20574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63.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"/>
          <p:cNvSpPr/>
          <p:nvPr/>
        </p:nvSpPr>
        <p:spPr>
          <a:xfrm>
            <a:off x="4648320" y="24382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"/>
          <p:cNvSpPr/>
          <p:nvPr/>
        </p:nvSpPr>
        <p:spPr>
          <a:xfrm>
            <a:off x="4267080" y="22860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67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"/>
          <p:cNvSpPr/>
          <p:nvPr/>
        </p:nvSpPr>
        <p:spPr>
          <a:xfrm>
            <a:off x="4648320" y="25909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"/>
          <p:cNvSpPr/>
          <p:nvPr/>
        </p:nvSpPr>
        <p:spPr>
          <a:xfrm>
            <a:off x="4875840" y="2438280"/>
            <a:ext cx="1067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MA-1, ASTT02T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"/>
          <p:cNvSpPr/>
          <p:nvPr/>
        </p:nvSpPr>
        <p:spPr>
          <a:xfrm>
            <a:off x="4267080" y="24382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71.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"/>
          <p:cNvSpPr/>
          <p:nvPr/>
        </p:nvSpPr>
        <p:spPr>
          <a:xfrm>
            <a:off x="4876920" y="2057400"/>
            <a:ext cx="129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AG01TC, ASCT01AC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"/>
          <p:cNvSpPr/>
          <p:nvPr/>
        </p:nvSpPr>
        <p:spPr>
          <a:xfrm>
            <a:off x="838080" y="3809880"/>
            <a:ext cx="2210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TG01CA, AJGA01TT, ASGA01TC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"/>
          <p:cNvSpPr/>
          <p:nvPr/>
        </p:nvSpPr>
        <p:spPr>
          <a:xfrm>
            <a:off x="6019920" y="3886200"/>
            <a:ext cx="0" cy="304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"/>
          <p:cNvSpPr/>
          <p:nvPr/>
        </p:nvSpPr>
        <p:spPr>
          <a:xfrm>
            <a:off x="6019920" y="4191120"/>
            <a:ext cx="380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"/>
          <p:cNvSpPr/>
          <p:nvPr/>
        </p:nvSpPr>
        <p:spPr>
          <a:xfrm>
            <a:off x="5867280" y="4191120"/>
            <a:ext cx="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"/>
          <p:cNvSpPr/>
          <p:nvPr/>
        </p:nvSpPr>
        <p:spPr>
          <a:xfrm>
            <a:off x="5867280" y="4648320"/>
            <a:ext cx="495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"/>
          <p:cNvSpPr/>
          <p:nvPr/>
        </p:nvSpPr>
        <p:spPr>
          <a:xfrm>
            <a:off x="5791320" y="464832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"/>
          <p:cNvSpPr/>
          <p:nvPr/>
        </p:nvSpPr>
        <p:spPr>
          <a:xfrm>
            <a:off x="5791320" y="4876920"/>
            <a:ext cx="457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"/>
          <p:cNvSpPr/>
          <p:nvPr/>
        </p:nvSpPr>
        <p:spPr>
          <a:xfrm>
            <a:off x="5562720" y="4857840"/>
            <a:ext cx="0" cy="171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"/>
          <p:cNvSpPr/>
          <p:nvPr/>
        </p:nvSpPr>
        <p:spPr>
          <a:xfrm>
            <a:off x="5562720" y="5029200"/>
            <a:ext cx="609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"/>
          <p:cNvSpPr/>
          <p:nvPr/>
        </p:nvSpPr>
        <p:spPr>
          <a:xfrm>
            <a:off x="4876920" y="5562720"/>
            <a:ext cx="73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TBP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"/>
          <p:cNvSpPr/>
          <p:nvPr/>
        </p:nvSpPr>
        <p:spPr>
          <a:xfrm>
            <a:off x="4876920" y="5715000"/>
            <a:ext cx="73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P.2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"/>
          <p:cNvSpPr/>
          <p:nvPr/>
        </p:nvSpPr>
        <p:spPr>
          <a:xfrm>
            <a:off x="6172200" y="5029200"/>
            <a:ext cx="0" cy="380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"/>
          <p:cNvSpPr/>
          <p:nvPr/>
        </p:nvSpPr>
        <p:spPr>
          <a:xfrm>
            <a:off x="6248520" y="4876920"/>
            <a:ext cx="0" cy="152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"/>
          <p:cNvSpPr/>
          <p:nvPr/>
        </p:nvSpPr>
        <p:spPr>
          <a:xfrm>
            <a:off x="6248520" y="502920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"/>
          <p:cNvSpPr/>
          <p:nvPr/>
        </p:nvSpPr>
        <p:spPr>
          <a:xfrm>
            <a:off x="6172200" y="54100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7-22T10:20:05Z</dcterms:created>
  <dc:creator>Axel</dc:creator>
  <dc:description/>
  <dc:language>en-US</dc:language>
  <cp:lastModifiedBy>susiej</cp:lastModifiedBy>
  <dcterms:modified xsi:type="dcterms:W3CDTF">2005-02-15T12:08:24Z</dcterms:modified>
  <cp:revision>7</cp:revision>
  <dc:subject/>
  <dc:title>PowerPoint Presentation</dc:title>
</cp:coreProperties>
</file>